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CC"/>
    <a:srgbClr val="FF00FF"/>
    <a:srgbClr val="0000FF"/>
    <a:srgbClr val="EAE2E8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FF424B-33C0-4ADC-9281-34FDC7E08D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7F05592-02EC-D8B0-3179-FD97D478E8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4BB605-2003-6E06-134D-F32910AF0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70DB28-4DD8-5727-A69E-68ECE5DF5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888785-FA0C-FFDE-B251-8D68A652C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496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1DD86F-F2BA-4EC6-3F4F-C16AC3771F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38075C0-B092-8770-8B7C-7D19386B62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8D4792-69B8-F27A-3F37-F29DB2607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9EE2BC-2AF7-736C-3E97-7B39048F7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805FDE-8A45-C00D-4E6A-A8189FEBA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057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23D6FEE-0F6D-582B-84FD-A95FBBC194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0DE5EC7-C8B5-073F-2D32-601AEB71C6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2A2C07-35B7-C390-045D-60F71FF9E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7DEC6D-7DB8-9A92-C1F8-424F29E43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EAABE7-3FA4-3BFB-D060-1CB322893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469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74B553-6340-1485-F1CF-FE160E4AA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CFEE8D0-9A12-1998-CE0F-8D7122770B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3F092C-9E78-9BCB-5CD1-1EBA3D207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26CA2F-3227-C79B-022E-B4561A355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FAA185-BCE3-F333-9585-E393E1C98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750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FE39E4-E07A-06BD-C119-1DBA2BF97B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13F2E2-B479-E1CC-1FCE-2E870608CA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32FD2D-9239-A5B8-4CE8-A49AC468C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2CAB6F-ED4B-0681-523C-5CEF5D464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5A64D0-DE24-B7D0-B6F4-DC02DF4A0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171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BE916D-7780-2141-099E-7A006ADD8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BD6267D-42BC-13E5-4238-1734280FDD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1A3386-906C-30B4-C584-18AEDBCD69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713EB29-1E3A-603A-310E-78D3232C0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DF52103-643B-D31A-633C-FF42843E3C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B673028-3F9D-AB48-1084-852BEC249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6193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B0C317-DCEA-67D1-D2B5-F60AF8D0C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F6526DB-C3CA-C50C-D664-B88206F27D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D9F6697-3C71-FF1D-2122-AE71C68CDC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A743B22-1ABD-8AF1-8302-AC172B2D83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42ADE03-3C12-F4E6-AA88-737F289F52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5EDA2B9-2987-D72B-2465-E7A26124A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6D6101D-B646-787B-3DBA-596F0323F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24FAEB7-0640-D9D5-763F-67D39F408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0315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74CAD3-ABE1-B2C9-51B6-C6B6904A09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6CF46FE-8C7A-3029-1E66-15CC2CEE6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5EA5DD3-E969-831D-237E-AA8A4C2F6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52E463E-26F6-7AE5-826A-C49CC5918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4349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E20C32C-CCE7-7E70-5A40-99613D7EC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8732289-E40E-3D05-721C-F49510DE3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593F23F-C2F3-E6AF-AFD0-7DF4FDC01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252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3B3242-7A81-431F-10DA-213BE110DE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7D35EE2-4286-A404-C0D0-F6EBBA793C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84D8993-FCBC-6177-39D9-FF5C78047F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A600311-602C-E8DA-9606-8BBC1FBF1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FC2E298-0D16-6081-A491-EC040D7F3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FBBE69A-211F-FB7D-68F1-34A0223CA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012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0CFEF6-AE6F-70D0-0E0B-600BC6BDA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C0D8531-7AAC-7D6E-8B56-5926993F64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56992FC-DDD4-DE94-69D6-F332518428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249B4DF-1945-F626-0B8E-CC76E4854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4D5CD1A-1F1E-B144-8E56-55D02C93B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84BFFF-F312-135B-7543-C0EBBEC63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143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24EA4E1-4B4E-B832-75FB-452A54FBA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FB2C9D0-C0D4-05C5-0A3D-4139AA968D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BA1688-B953-0121-B707-C095B0A104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A147A-206C-4F6A-987C-DA732B98B7F3}" type="datetimeFigureOut">
              <a:rPr kumimoji="1" lang="ja-JP" altLang="en-US" smtClean="0"/>
              <a:t>2024/8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610EB1-D505-0295-DEC0-ED8D0948FD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CBBF71-AEAC-1979-ACCD-2599FF606B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4457E-0C50-4A48-A6BB-6CFBA8328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68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92E05F2E-ABC9-D334-8B90-183423862D38}"/>
              </a:ext>
            </a:extLst>
          </p:cNvPr>
          <p:cNvGrpSpPr/>
          <p:nvPr/>
        </p:nvGrpSpPr>
        <p:grpSpPr>
          <a:xfrm>
            <a:off x="2742921" y="2042301"/>
            <a:ext cx="3173090" cy="3176376"/>
            <a:chOff x="957245" y="2032356"/>
            <a:chExt cx="4117568" cy="4121831"/>
          </a:xfrm>
        </p:grpSpPr>
        <p:sp>
          <p:nvSpPr>
            <p:cNvPr id="48" name="楕円 47">
              <a:extLst>
                <a:ext uri="{FF2B5EF4-FFF2-40B4-BE49-F238E27FC236}">
                  <a16:creationId xmlns:a16="http://schemas.microsoft.com/office/drawing/2014/main" id="{E53E8A5D-1D13-37BF-CCFF-B6593604B79D}"/>
                </a:ext>
              </a:extLst>
            </p:cNvPr>
            <p:cNvSpPr/>
            <p:nvPr/>
          </p:nvSpPr>
          <p:spPr>
            <a:xfrm>
              <a:off x="957245" y="2033848"/>
              <a:ext cx="4117568" cy="4117568"/>
            </a:xfrm>
            <a:prstGeom prst="ellipse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楕円 48">
              <a:extLst>
                <a:ext uri="{FF2B5EF4-FFF2-40B4-BE49-F238E27FC236}">
                  <a16:creationId xmlns:a16="http://schemas.microsoft.com/office/drawing/2014/main" id="{956C9161-CB49-90FF-4E44-A4A09D9E32BB}"/>
                </a:ext>
              </a:extLst>
            </p:cNvPr>
            <p:cNvSpPr/>
            <p:nvPr/>
          </p:nvSpPr>
          <p:spPr>
            <a:xfrm>
              <a:off x="1506946" y="2614395"/>
              <a:ext cx="3001749" cy="2984330"/>
            </a:xfrm>
            <a:prstGeom prst="ellipse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" name="楕円 49">
              <a:extLst>
                <a:ext uri="{FF2B5EF4-FFF2-40B4-BE49-F238E27FC236}">
                  <a16:creationId xmlns:a16="http://schemas.microsoft.com/office/drawing/2014/main" id="{3356DFC5-B104-BE8B-A9FC-93F4105975AF}"/>
                </a:ext>
              </a:extLst>
            </p:cNvPr>
            <p:cNvSpPr/>
            <p:nvPr/>
          </p:nvSpPr>
          <p:spPr>
            <a:xfrm>
              <a:off x="2064541" y="3168215"/>
              <a:ext cx="1902550" cy="1902550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903DBFDD-08A2-B50F-BDB3-5E6DE5E5939D}"/>
                </a:ext>
              </a:extLst>
            </p:cNvPr>
            <p:cNvCxnSpPr>
              <a:stCxn id="48" idx="2"/>
              <a:endCxn id="48" idx="6"/>
            </p:cNvCxnSpPr>
            <p:nvPr/>
          </p:nvCxnSpPr>
          <p:spPr>
            <a:xfrm>
              <a:off x="957245" y="4092632"/>
              <a:ext cx="411756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819A3FD7-C72E-73C3-E246-AE1486FA29B9}"/>
                </a:ext>
              </a:extLst>
            </p:cNvPr>
            <p:cNvCxnSpPr>
              <a:cxnSpLocks/>
            </p:cNvCxnSpPr>
            <p:nvPr/>
          </p:nvCxnSpPr>
          <p:spPr>
            <a:xfrm rot="3600000">
              <a:off x="955965" y="4095403"/>
              <a:ext cx="411756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234E9181-0918-02A8-CB3B-D1CFA75B18C3}"/>
                </a:ext>
              </a:extLst>
            </p:cNvPr>
            <p:cNvCxnSpPr>
              <a:cxnSpLocks/>
            </p:cNvCxnSpPr>
            <p:nvPr/>
          </p:nvCxnSpPr>
          <p:spPr>
            <a:xfrm rot="7200000">
              <a:off x="947651" y="4091140"/>
              <a:ext cx="411756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F1841C5-998F-EF56-9D6F-B7852FFF6337}"/>
              </a:ext>
            </a:extLst>
          </p:cNvPr>
          <p:cNvSpPr txBox="1"/>
          <p:nvPr/>
        </p:nvSpPr>
        <p:spPr>
          <a:xfrm>
            <a:off x="4176305" y="2121116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49D622A-4D72-F7A8-EE97-C360E6D996D6}"/>
              </a:ext>
            </a:extLst>
          </p:cNvPr>
          <p:cNvSpPr txBox="1"/>
          <p:nvPr/>
        </p:nvSpPr>
        <p:spPr>
          <a:xfrm>
            <a:off x="2961935" y="2736949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38AB522-AD59-09D6-ABBC-7377E7E49AA2}"/>
              </a:ext>
            </a:extLst>
          </p:cNvPr>
          <p:cNvSpPr txBox="1"/>
          <p:nvPr/>
        </p:nvSpPr>
        <p:spPr>
          <a:xfrm>
            <a:off x="2965815" y="4108749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BBE772B-F0EB-D12A-DC27-45F55161DA9C}"/>
              </a:ext>
            </a:extLst>
          </p:cNvPr>
          <p:cNvSpPr txBox="1"/>
          <p:nvPr/>
        </p:nvSpPr>
        <p:spPr>
          <a:xfrm>
            <a:off x="4154455" y="485605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2D72829-36A5-6E0F-1C56-47BF6E18A624}"/>
              </a:ext>
            </a:extLst>
          </p:cNvPr>
          <p:cNvSpPr txBox="1"/>
          <p:nvPr/>
        </p:nvSpPr>
        <p:spPr>
          <a:xfrm>
            <a:off x="5337368" y="4161016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FC5401B-C301-3F9A-807D-39D09EBF515D}"/>
              </a:ext>
            </a:extLst>
          </p:cNvPr>
          <p:cNvSpPr txBox="1"/>
          <p:nvPr/>
        </p:nvSpPr>
        <p:spPr>
          <a:xfrm>
            <a:off x="5368594" y="2761191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64F641B-063C-0EB7-344A-F6FD8EF12E8C}"/>
              </a:ext>
            </a:extLst>
          </p:cNvPr>
          <p:cNvSpPr txBox="1"/>
          <p:nvPr/>
        </p:nvSpPr>
        <p:spPr>
          <a:xfrm>
            <a:off x="4161503" y="2561734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756346D-FACF-9C25-A2FC-3D3704BBD420}"/>
              </a:ext>
            </a:extLst>
          </p:cNvPr>
          <p:cNvSpPr txBox="1"/>
          <p:nvPr/>
        </p:nvSpPr>
        <p:spPr>
          <a:xfrm>
            <a:off x="3357401" y="2946830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3F957F9-35D7-A4C5-78B9-D1065D17BF5D}"/>
              </a:ext>
            </a:extLst>
          </p:cNvPr>
          <p:cNvSpPr txBox="1"/>
          <p:nvPr/>
        </p:nvSpPr>
        <p:spPr>
          <a:xfrm>
            <a:off x="3330732" y="3902996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E739FC2-4C9F-FA98-1DE2-FC33EA0289DC}"/>
              </a:ext>
            </a:extLst>
          </p:cNvPr>
          <p:cNvSpPr txBox="1"/>
          <p:nvPr/>
        </p:nvSpPr>
        <p:spPr>
          <a:xfrm>
            <a:off x="4083140" y="4442610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94BB735-9D66-3E39-96C7-5A93DC2A67D9}"/>
              </a:ext>
            </a:extLst>
          </p:cNvPr>
          <p:cNvSpPr txBox="1"/>
          <p:nvPr/>
        </p:nvSpPr>
        <p:spPr>
          <a:xfrm>
            <a:off x="4939693" y="3968242"/>
            <a:ext cx="4509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04B7A17-0E96-FC6E-D5D9-6A355A46A979}"/>
              </a:ext>
            </a:extLst>
          </p:cNvPr>
          <p:cNvSpPr txBox="1"/>
          <p:nvPr/>
        </p:nvSpPr>
        <p:spPr>
          <a:xfrm>
            <a:off x="4942295" y="3076108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AC7F983-AB7A-3EEC-EA6A-D714E279D8CB}"/>
              </a:ext>
            </a:extLst>
          </p:cNvPr>
          <p:cNvSpPr txBox="1"/>
          <p:nvPr/>
        </p:nvSpPr>
        <p:spPr>
          <a:xfrm>
            <a:off x="4081193" y="2997279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25D6341-D499-11B6-3FC3-F472EA1A78A1}"/>
              </a:ext>
            </a:extLst>
          </p:cNvPr>
          <p:cNvSpPr txBox="1"/>
          <p:nvPr/>
        </p:nvSpPr>
        <p:spPr>
          <a:xfrm>
            <a:off x="3686678" y="3296185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317ADDB-B526-168B-B9D9-E0EF6B2C94E8}"/>
              </a:ext>
            </a:extLst>
          </p:cNvPr>
          <p:cNvSpPr txBox="1"/>
          <p:nvPr/>
        </p:nvSpPr>
        <p:spPr>
          <a:xfrm>
            <a:off x="3705842" y="3697244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1D65EE6-1865-31EA-053C-2449A397CE1D}"/>
              </a:ext>
            </a:extLst>
          </p:cNvPr>
          <p:cNvSpPr txBox="1"/>
          <p:nvPr/>
        </p:nvSpPr>
        <p:spPr>
          <a:xfrm>
            <a:off x="4094053" y="3904937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6F9B7C7-4C48-8E0F-1170-3AB5450DB06D}"/>
              </a:ext>
            </a:extLst>
          </p:cNvPr>
          <p:cNvSpPr txBox="1"/>
          <p:nvPr/>
        </p:nvSpPr>
        <p:spPr>
          <a:xfrm>
            <a:off x="4454880" y="3630054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82425501-E09C-40B7-B05B-B0A5121D7547}"/>
              </a:ext>
            </a:extLst>
          </p:cNvPr>
          <p:cNvSpPr txBox="1"/>
          <p:nvPr/>
        </p:nvSpPr>
        <p:spPr>
          <a:xfrm>
            <a:off x="4475976" y="3212987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FC14D4E-9EA1-0655-D018-8E0ECD7E829D}"/>
              </a:ext>
            </a:extLst>
          </p:cNvPr>
          <p:cNvSpPr txBox="1"/>
          <p:nvPr/>
        </p:nvSpPr>
        <p:spPr>
          <a:xfrm>
            <a:off x="8711331" y="18335"/>
            <a:ext cx="33395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Tsuruda T, et al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E48500C1-5456-F236-9C6D-844D9E51AA1B}"/>
              </a:ext>
            </a:extLst>
          </p:cNvPr>
          <p:cNvSpPr txBox="1"/>
          <p:nvPr/>
        </p:nvSpPr>
        <p:spPr>
          <a:xfrm>
            <a:off x="6742705" y="1160892"/>
            <a:ext cx="2262158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asal anteroseptal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sal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inferoseptal</a:t>
            </a: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asal inferior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asal inferolateral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asal anterolateral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id anterior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id anteroseptal</a:t>
            </a:r>
          </a:p>
          <a:p>
            <a:pPr marL="342900" indent="-342900">
              <a:buAutoNum type="arabicPeriod"/>
            </a:pP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id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inferoseptal</a:t>
            </a: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id inferior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id inferolateral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id anterolateral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ical anterior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ical anteroseptal</a:t>
            </a:r>
          </a:p>
          <a:p>
            <a:pPr marL="342900" indent="-342900">
              <a:buAutoNum type="arabicPeriod"/>
            </a:pP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i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al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inferoseptal</a:t>
            </a: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ical inferior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ical inferolateral</a:t>
            </a:r>
          </a:p>
          <a:p>
            <a:pPr marL="342900" indent="-342900">
              <a:buAutoNum type="arabicPeriod"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pical anterolateral</a:t>
            </a:r>
          </a:p>
          <a:p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3001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2</TotalTime>
  <Words>65</Words>
  <Application>Microsoft Office PowerPoint</Application>
  <PresentationFormat>ワイド画面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敏博 鶴田</dc:creator>
  <cp:lastModifiedBy>敏博 鶴田</cp:lastModifiedBy>
  <cp:revision>198</cp:revision>
  <cp:lastPrinted>2024-08-16T07:18:40Z</cp:lastPrinted>
  <dcterms:created xsi:type="dcterms:W3CDTF">2023-12-18T10:59:25Z</dcterms:created>
  <dcterms:modified xsi:type="dcterms:W3CDTF">2024-08-16T07:18:52Z</dcterms:modified>
</cp:coreProperties>
</file>